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2314" autoAdjust="0"/>
    <p:restoredTop sz="95673"/>
  </p:normalViewPr>
  <p:slideViewPr>
    <p:cSldViewPr snapToGrid="0" showGuides="1">
      <p:cViewPr varScale="1">
        <p:scale>
          <a:sx n="75" d="100"/>
          <a:sy n="75" d="100"/>
        </p:scale>
        <p:origin x="106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-58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雄康 大野" userId="289040ba27705a35" providerId="LiveId" clId="{59DFF2D7-9AEF-4F77-BBEF-9FA683D532FE}"/>
    <pc:docChg chg="modSld">
      <pc:chgData name="雄康 大野" userId="289040ba27705a35" providerId="LiveId" clId="{59DFF2D7-9AEF-4F77-BBEF-9FA683D532FE}" dt="2024-11-12T11:54:59.922" v="1"/>
      <pc:docMkLst>
        <pc:docMk/>
      </pc:docMkLst>
      <pc:sldChg chg="modSp mod modNotesTx">
        <pc:chgData name="雄康 大野" userId="289040ba27705a35" providerId="LiveId" clId="{59DFF2D7-9AEF-4F77-BBEF-9FA683D532FE}" dt="2024-11-12T11:54:59.922" v="1"/>
        <pc:sldMkLst>
          <pc:docMk/>
          <pc:sldMk cId="202590526" sldId="256"/>
        </pc:sldMkLst>
        <pc:spChg chg="mod">
          <ac:chgData name="雄康 大野" userId="289040ba27705a35" providerId="LiveId" clId="{59DFF2D7-9AEF-4F77-BBEF-9FA683D532FE}" dt="2024-11-12T11:49:13.919" v="0"/>
          <ac:spMkLst>
            <pc:docMk/>
            <pc:sldMk cId="202590526" sldId="256"/>
            <ac:spMk id="20" creationId="{92639325-C21A-40E8-AF05-E34D35BFA43B}"/>
          </ac:spMkLst>
        </pc:spChg>
      </pc:sldChg>
    </pc:docChg>
  </pc:docChgLst>
  <pc:docChgLst>
    <pc:chgData name="雄康 大野" userId="289040ba27705a35" providerId="LiveId" clId="{B577D62D-8999-4271-B4D6-5DA18B215022}"/>
    <pc:docChg chg="modSld">
      <pc:chgData name="雄康 大野" userId="289040ba27705a35" providerId="LiveId" clId="{B577D62D-8999-4271-B4D6-5DA18B215022}" dt="2024-10-17T05:19:19.802" v="15" actId="20577"/>
      <pc:docMkLst>
        <pc:docMk/>
      </pc:docMkLst>
      <pc:sldChg chg="modSp mod">
        <pc:chgData name="雄康 大野" userId="289040ba27705a35" providerId="LiveId" clId="{B577D62D-8999-4271-B4D6-5DA18B215022}" dt="2024-10-17T05:19:19.802" v="15" actId="20577"/>
        <pc:sldMkLst>
          <pc:docMk/>
          <pc:sldMk cId="202590526" sldId="256"/>
        </pc:sldMkLst>
        <pc:spChg chg="mod">
          <ac:chgData name="雄康 大野" userId="289040ba27705a35" providerId="LiveId" clId="{B577D62D-8999-4271-B4D6-5DA18B215022}" dt="2024-10-17T05:19:19.802" v="15" actId="20577"/>
          <ac:spMkLst>
            <pc:docMk/>
            <pc:sldMk cId="202590526" sldId="256"/>
            <ac:spMk id="20" creationId="{92639325-C21A-40E8-AF05-E34D35BFA43B}"/>
          </ac:spMkLst>
        </pc:spChg>
      </pc:sldChg>
    </pc:docChg>
  </pc:docChgLst>
  <pc:docChgLst>
    <pc:chgData name="雄康 大野" userId="289040ba27705a35" providerId="LiveId" clId="{7809B920-A9C2-4AB8-8881-AB78022E51E7}"/>
    <pc:docChg chg="custSel modSld">
      <pc:chgData name="雄康 大野" userId="289040ba27705a35" providerId="LiveId" clId="{7809B920-A9C2-4AB8-8881-AB78022E51E7}" dt="2024-07-06T09:58:11.936" v="82" actId="20577"/>
      <pc:docMkLst>
        <pc:docMk/>
      </pc:docMkLst>
      <pc:sldChg chg="addSp delSp modSp mod">
        <pc:chgData name="雄康 大野" userId="289040ba27705a35" providerId="LiveId" clId="{7809B920-A9C2-4AB8-8881-AB78022E51E7}" dt="2024-07-06T09:58:11.936" v="82" actId="20577"/>
        <pc:sldMkLst>
          <pc:docMk/>
          <pc:sldMk cId="202590526" sldId="256"/>
        </pc:sldMkLst>
        <pc:spChg chg="mod">
          <ac:chgData name="雄康 大野" userId="289040ba27705a35" providerId="LiveId" clId="{7809B920-A9C2-4AB8-8881-AB78022E51E7}" dt="2024-07-06T09:55:31.872" v="56" actId="1036"/>
          <ac:spMkLst>
            <pc:docMk/>
            <pc:sldMk cId="202590526" sldId="256"/>
            <ac:spMk id="2" creationId="{6577588B-FF80-4E17-8944-8A6C2E6470A7}"/>
          </ac:spMkLst>
        </pc:spChg>
        <pc:spChg chg="mod">
          <ac:chgData name="雄康 大野" userId="289040ba27705a35" providerId="LiveId" clId="{7809B920-A9C2-4AB8-8881-AB78022E51E7}" dt="2024-07-06T09:57:38.647" v="77"/>
          <ac:spMkLst>
            <pc:docMk/>
            <pc:sldMk cId="202590526" sldId="256"/>
            <ac:spMk id="4" creationId="{50E7CE07-A4CF-40C0-BA53-BBB97857C6AA}"/>
          </ac:spMkLst>
        </pc:spChg>
        <pc:spChg chg="mod">
          <ac:chgData name="雄康 大野" userId="289040ba27705a35" providerId="LiveId" clId="{7809B920-A9C2-4AB8-8881-AB78022E51E7}" dt="2024-07-06T09:56:56.425" v="75"/>
          <ac:spMkLst>
            <pc:docMk/>
            <pc:sldMk cId="202590526" sldId="256"/>
            <ac:spMk id="5" creationId="{F4FE7D7B-8400-4F8C-9A47-288432878906}"/>
          </ac:spMkLst>
        </pc:spChg>
        <pc:spChg chg="mod">
          <ac:chgData name="雄康 大野" userId="289040ba27705a35" providerId="LiveId" clId="{7809B920-A9C2-4AB8-8881-AB78022E51E7}" dt="2024-07-06T09:57:35.554" v="76"/>
          <ac:spMkLst>
            <pc:docMk/>
            <pc:sldMk cId="202590526" sldId="256"/>
            <ac:spMk id="8" creationId="{19B88850-95CB-4592-9DE5-47C08D89D6E8}"/>
          </ac:spMkLst>
        </pc:spChg>
        <pc:spChg chg="add del">
          <ac:chgData name="雄康 大野" userId="289040ba27705a35" providerId="LiveId" clId="{7809B920-A9C2-4AB8-8881-AB78022E51E7}" dt="2024-07-06T09:28:06.069" v="3" actId="478"/>
          <ac:spMkLst>
            <pc:docMk/>
            <pc:sldMk cId="202590526" sldId="256"/>
            <ac:spMk id="10" creationId="{79E4C7C4-8AF2-CD10-D3A5-26ABE720E2C3}"/>
          </ac:spMkLst>
        </pc:spChg>
        <pc:spChg chg="add del">
          <ac:chgData name="雄康 大野" userId="289040ba27705a35" providerId="LiveId" clId="{7809B920-A9C2-4AB8-8881-AB78022E51E7}" dt="2024-07-06T09:28:21.894" v="5" actId="478"/>
          <ac:spMkLst>
            <pc:docMk/>
            <pc:sldMk cId="202590526" sldId="256"/>
            <ac:spMk id="12" creationId="{45CD04D9-9160-6034-257F-D8C0A12DB1D0}"/>
          </ac:spMkLst>
        </pc:spChg>
        <pc:spChg chg="mod">
          <ac:chgData name="雄康 大野" userId="289040ba27705a35" providerId="LiveId" clId="{7809B920-A9C2-4AB8-8881-AB78022E51E7}" dt="2024-07-06T09:56:08.115" v="74" actId="6549"/>
          <ac:spMkLst>
            <pc:docMk/>
            <pc:sldMk cId="202590526" sldId="256"/>
            <ac:spMk id="19" creationId="{4436F4F9-9BC8-4176-A56E-ED2646435F2C}"/>
          </ac:spMkLst>
        </pc:spChg>
        <pc:spChg chg="mod">
          <ac:chgData name="雄康 大野" userId="289040ba27705a35" providerId="LiveId" clId="{7809B920-A9C2-4AB8-8881-AB78022E51E7}" dt="2024-07-06T09:58:11.936" v="82" actId="20577"/>
          <ac:spMkLst>
            <pc:docMk/>
            <pc:sldMk cId="202590526" sldId="256"/>
            <ac:spMk id="20" creationId="{92639325-C21A-40E8-AF05-E34D35BFA43B}"/>
          </ac:spMkLst>
        </pc:spChg>
        <pc:spChg chg="add del">
          <ac:chgData name="雄康 大野" userId="289040ba27705a35" providerId="LiveId" clId="{7809B920-A9C2-4AB8-8881-AB78022E51E7}" dt="2024-07-06T09:53:44.373" v="27" actId="478"/>
          <ac:spMkLst>
            <pc:docMk/>
            <pc:sldMk cId="202590526" sldId="256"/>
            <ac:spMk id="22" creationId="{3969D218-F146-11D4-DF1C-0F9537EA8EA7}"/>
          </ac:spMkLst>
        </pc:spChg>
        <pc:spChg chg="mod">
          <ac:chgData name="雄康 大野" userId="289040ba27705a35" providerId="LiveId" clId="{7809B920-A9C2-4AB8-8881-AB78022E51E7}" dt="2024-07-06T09:57:50.781" v="78"/>
          <ac:spMkLst>
            <pc:docMk/>
            <pc:sldMk cId="202590526" sldId="256"/>
            <ac:spMk id="31" creationId="{981F9BE8-060C-453B-83E0-7B2BD3D66D5A}"/>
          </ac:spMkLst>
        </pc:spChg>
        <pc:picChg chg="add del mod">
          <ac:chgData name="雄康 大野" userId="289040ba27705a35" providerId="LiveId" clId="{7809B920-A9C2-4AB8-8881-AB78022E51E7}" dt="2024-07-06T09:29:36.764" v="10" actId="478"/>
          <ac:picMkLst>
            <pc:docMk/>
            <pc:sldMk cId="202590526" sldId="256"/>
            <ac:picMk id="14" creationId="{CB06E6EA-F6E2-0277-ABAC-F2D9ECA3C53E}"/>
          </ac:picMkLst>
        </pc:picChg>
        <pc:picChg chg="add del mod modCrop">
          <ac:chgData name="雄康 大野" userId="289040ba27705a35" providerId="LiveId" clId="{7809B920-A9C2-4AB8-8881-AB78022E51E7}" dt="2024-07-06T09:31:26.287" v="25" actId="478"/>
          <ac:picMkLst>
            <pc:docMk/>
            <pc:sldMk cId="202590526" sldId="256"/>
            <ac:picMk id="16" creationId="{55E4FDDB-01B1-48BF-FA3A-C9CCFD5013F1}"/>
          </ac:picMkLst>
        </pc:picChg>
        <pc:picChg chg="del">
          <ac:chgData name="雄康 大野" userId="289040ba27705a35" providerId="LiveId" clId="{7809B920-A9C2-4AB8-8881-AB78022E51E7}" dt="2024-07-06T09:27:50.273" v="1" actId="478"/>
          <ac:picMkLst>
            <pc:docMk/>
            <pc:sldMk cId="202590526" sldId="256"/>
            <ac:picMk id="17" creationId="{00D0AB6E-F038-4817-8712-7E7F63F131A9}"/>
          </ac:picMkLst>
        </pc:picChg>
        <pc:picChg chg="del">
          <ac:chgData name="雄康 大野" userId="289040ba27705a35" providerId="LiveId" clId="{7809B920-A9C2-4AB8-8881-AB78022E51E7}" dt="2024-07-06T09:27:47.007" v="0" actId="478"/>
          <ac:picMkLst>
            <pc:docMk/>
            <pc:sldMk cId="202590526" sldId="256"/>
            <ac:picMk id="18" creationId="{72BD8202-E400-46A1-B80F-F81677E13B6B}"/>
          </ac:picMkLst>
        </pc:picChg>
        <pc:picChg chg="add mod modCrop">
          <ac:chgData name="雄康 大野" userId="289040ba27705a35" providerId="LiveId" clId="{7809B920-A9C2-4AB8-8881-AB78022E51E7}" dt="2024-07-06T09:55:53.454" v="73" actId="1035"/>
          <ac:picMkLst>
            <pc:docMk/>
            <pc:sldMk cId="202590526" sldId="256"/>
            <ac:picMk id="24" creationId="{2153EDC2-8700-57D7-E87A-ED17B9BF9E37}"/>
          </ac:picMkLst>
        </pc:picChg>
        <pc:picChg chg="add mod modCrop">
          <ac:chgData name="雄康 大野" userId="289040ba27705a35" providerId="LiveId" clId="{7809B920-A9C2-4AB8-8881-AB78022E51E7}" dt="2024-07-06T09:55:48.636" v="71" actId="1035"/>
          <ac:picMkLst>
            <pc:docMk/>
            <pc:sldMk cId="202590526" sldId="256"/>
            <ac:picMk id="26" creationId="{01392726-138B-D8D4-73C6-89DE36157319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3354C6-6A26-47EE-AD20-F9A9B605824B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DD30A3-6C99-4528-BB73-B2DD98632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1135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1 Fig. Distribution of propensity scores in the unmatched (A) and matched groups (B).</a:t>
            </a: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DD30A3-6C99-4528-BB73-B2DD986321F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73934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203826-FCED-4ADB-AD72-124E292C01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D4D1E65-AABF-46D2-86C0-C6C23E07AE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5F99F52-9919-4076-82F2-4E9FDFD59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A4366-D326-4E73-AAD6-A3EB6BA0DBFF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DB8B490-DD5C-4C21-A97A-2C70201F7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B443632-E763-467A-AEBC-5D97B98A4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0BD9-07F8-4EBD-B82F-D9B4D75C8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6219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659B81-6AF2-49F4-9A2A-2FE73D476D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994400B-89A6-4416-93E0-14145F3570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94E64DC-B7A4-4E8C-B186-91C236FF9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A4366-D326-4E73-AAD6-A3EB6BA0DBFF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DF5A5E-AB85-4B32-93EE-62D1C06E4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8AEEF0-B063-450F-933A-A728C9E3B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0BD9-07F8-4EBD-B82F-D9B4D75C8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3620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EE0BA0A-1124-4C6A-8E41-4DEA852339B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CD699CC-EB24-4FE2-A13A-66EA942217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C10CC6C-DCAD-4F66-85F9-B8DC77B09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A4366-D326-4E73-AAD6-A3EB6BA0DBFF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DB1BE19-F85B-4E6E-A426-E06B3D527A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D694D8C-993F-4C68-92FE-FB03C44A8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0BD9-07F8-4EBD-B82F-D9B4D75C8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528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EE3674-0562-4832-B01D-69BD1C1DAD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D2788C7-4761-412C-84DD-35035FC084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42894A-B64A-4BFB-B287-9E36EE3C6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A4366-D326-4E73-AAD6-A3EB6BA0DBFF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A9F72F-5D01-4E3C-8B33-538A1572D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57B1B38-2DF7-457C-9C0C-FB482E1C5D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0BD9-07F8-4EBD-B82F-D9B4D75C8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2390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D09B739-5C32-450A-911C-CF955F4D1C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7EC9251-9691-4A68-90FA-0620504D5B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BA32EA-57AF-4B23-8FAD-5C99F0846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A4366-D326-4E73-AAD6-A3EB6BA0DBFF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35B398D-8FA5-4596-9EA1-3AB9E6CE94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269D19-67C6-4FCE-8FD2-949E1D1329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0BD9-07F8-4EBD-B82F-D9B4D75C8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1041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0547AE-5ECF-424F-88BE-45696291F6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548E531-8DE4-4E7F-87B5-0F05C00728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57FBF12-8AB3-41A7-A3C2-201309C5CF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FC99F78-CCAB-426A-AFBE-CAE11B474E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A4366-D326-4E73-AAD6-A3EB6BA0DBFF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CBEBE94-7151-45C0-A32F-1C5216A90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43EF07A-F072-4189-A4EC-D8C348269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0BD9-07F8-4EBD-B82F-D9B4D75C8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6352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86F61E-ED40-4273-A131-DDDC97707C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A0B30E3-CFB7-452C-8F35-4EEAA07520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9D5C83E-D7BD-491A-962D-F47BDB8593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B1E0F3C-F21A-4B99-A69B-6454949E50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DCAB681-F445-425A-8ABA-2FD28EB76F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5AE9B5A-AA2C-4244-861E-CF6FF1B61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A4366-D326-4E73-AAD6-A3EB6BA0DBFF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66BF27D-AB89-4E8A-A68B-8A904F608E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496D08F-8E73-4CB8-A977-97C07624D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0BD9-07F8-4EBD-B82F-D9B4D75C8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25284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DE21B28-84EB-4430-97ED-E5119D7A6F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C3A6188-48B0-4626-B365-7AC90DA0B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A4366-D326-4E73-AAD6-A3EB6BA0DBFF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8DC481A-B553-45CE-9F26-3D1DAA057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B95847D-64AD-485D-ACB0-0357359C46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0BD9-07F8-4EBD-B82F-D9B4D75C8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0520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794465A-178E-452D-A5C7-4797FD2ED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A4366-D326-4E73-AAD6-A3EB6BA0DBFF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9ED7EDD-1AC5-4F95-898C-59D994534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5DBE13A-2A40-4F46-98CA-9B99B2F02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0BD9-07F8-4EBD-B82F-D9B4D75C8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5238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FC77DD-2970-444F-9FF3-F11929016E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3585D8F-4BBD-47D0-800A-0F25F3BB7F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061D95E-6AED-483C-B22B-709A8CB51D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D3A7582-995F-489A-8BF2-97B9AC1D1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A4366-D326-4E73-AAD6-A3EB6BA0DBFF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DA30A3-0456-4EB3-94E8-126CFE33DA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2813278-70DF-4EEC-8922-8A3130537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0BD9-07F8-4EBD-B82F-D9B4D75C8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8410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4FC4E9-C7BD-4F4F-BA8A-D8297917D6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6DDC54A-325E-4074-85D4-FCA25ABF52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33D9F25-A7F6-455B-A97A-4E255463BE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C334FC9-35B9-4EB6-B162-B84016C33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A4366-D326-4E73-AAD6-A3EB6BA0DBFF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BA8605A-5B0F-4B7B-BF37-6C805662F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2C9867F-9917-4E17-BA6F-E669B83E3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0BD9-07F8-4EBD-B82F-D9B4D75C8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5904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174FCAC-593E-4DE9-B05A-0B478C1789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CB0EB38-B425-4117-9BFC-7FB5A572F3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54DAD32-8DA8-4B45-B42A-22E4A8F6D9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4A4366-D326-4E73-AAD6-A3EB6BA0DBFF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30E5AD-466E-4E0F-8646-64A7AD7CE8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7C40CB9-A831-4764-B976-943A7F6B00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E40BD9-07F8-4EBD-B82F-D9B4D75C86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375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C091222-E92E-4BA2-87CB-2433D2A95901}"/>
              </a:ext>
            </a:extLst>
          </p:cNvPr>
          <p:cNvSpPr txBox="1"/>
          <p:nvPr/>
        </p:nvSpPr>
        <p:spPr>
          <a:xfrm rot="16200000">
            <a:off x="-713556" y="3803529"/>
            <a:ext cx="21202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Propensity score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577588B-FF80-4E17-8944-8A6C2E6470A7}"/>
              </a:ext>
            </a:extLst>
          </p:cNvPr>
          <p:cNvSpPr txBox="1"/>
          <p:nvPr/>
        </p:nvSpPr>
        <p:spPr>
          <a:xfrm>
            <a:off x="921986" y="5971209"/>
            <a:ext cx="47986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umber of patient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3BB571E-1B8E-46F5-9E3E-0AE3EA3E07B7}"/>
              </a:ext>
            </a:extLst>
          </p:cNvPr>
          <p:cNvSpPr txBox="1"/>
          <p:nvPr/>
        </p:nvSpPr>
        <p:spPr>
          <a:xfrm>
            <a:off x="607301" y="1625490"/>
            <a:ext cx="52425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Unmatched groups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6325BAE-ED77-479D-8130-53164230642B}"/>
              </a:ext>
            </a:extLst>
          </p:cNvPr>
          <p:cNvSpPr txBox="1"/>
          <p:nvPr/>
        </p:nvSpPr>
        <p:spPr>
          <a:xfrm>
            <a:off x="6307013" y="1622264"/>
            <a:ext cx="54277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atched groups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81F9BE8-060C-453B-83E0-7B2BD3D66D5A}"/>
              </a:ext>
            </a:extLst>
          </p:cNvPr>
          <p:cNvSpPr txBox="1"/>
          <p:nvPr/>
        </p:nvSpPr>
        <p:spPr>
          <a:xfrm>
            <a:off x="6650940" y="2109505"/>
            <a:ext cx="237136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tandard vehicle group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397988F-A2CE-42E9-B3F6-5C5AC34CECA3}"/>
              </a:ext>
            </a:extLst>
          </p:cNvPr>
          <p:cNvSpPr txBox="1"/>
          <p:nvPr/>
        </p:nvSpPr>
        <p:spPr>
          <a:xfrm>
            <a:off x="300942" y="1579369"/>
            <a:ext cx="497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10C0A60B-E938-4191-BF2B-151DE04B9588}"/>
              </a:ext>
            </a:extLst>
          </p:cNvPr>
          <p:cNvSpPr txBox="1"/>
          <p:nvPr/>
        </p:nvSpPr>
        <p:spPr>
          <a:xfrm>
            <a:off x="6359323" y="1576799"/>
            <a:ext cx="497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CABC44F8-FAA6-43BB-A080-DC7EED2FBB6D}"/>
              </a:ext>
            </a:extLst>
          </p:cNvPr>
          <p:cNvSpPr txBox="1"/>
          <p:nvPr/>
        </p:nvSpPr>
        <p:spPr>
          <a:xfrm rot="16200000">
            <a:off x="5077626" y="3885917"/>
            <a:ext cx="21202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Propensity score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0E7CE07-A4CF-40C0-BA53-BBB97857C6AA}"/>
              </a:ext>
            </a:extLst>
          </p:cNvPr>
          <p:cNvSpPr txBox="1"/>
          <p:nvPr/>
        </p:nvSpPr>
        <p:spPr>
          <a:xfrm>
            <a:off x="9391031" y="2109505"/>
            <a:ext cx="210699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K-car vehicle group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4FE7D7B-8400-4F8C-9A47-288432878906}"/>
              </a:ext>
            </a:extLst>
          </p:cNvPr>
          <p:cNvSpPr txBox="1"/>
          <p:nvPr/>
        </p:nvSpPr>
        <p:spPr>
          <a:xfrm>
            <a:off x="949947" y="2100175"/>
            <a:ext cx="237136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tandard vehicle group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9B88850-95CB-4592-9DE5-47C08D89D6E8}"/>
              </a:ext>
            </a:extLst>
          </p:cNvPr>
          <p:cNvSpPr txBox="1"/>
          <p:nvPr/>
        </p:nvSpPr>
        <p:spPr>
          <a:xfrm>
            <a:off x="3690038" y="2100175"/>
            <a:ext cx="210699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K-car vehicle group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436F4F9-9BC8-4176-A56E-ED2646435F2C}"/>
              </a:ext>
            </a:extLst>
          </p:cNvPr>
          <p:cNvSpPr txBox="1"/>
          <p:nvPr/>
        </p:nvSpPr>
        <p:spPr>
          <a:xfrm>
            <a:off x="6856956" y="5971209"/>
            <a:ext cx="47986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umber of patient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2639325-C21A-40E8-AF05-E34D35BFA43B}"/>
              </a:ext>
            </a:extLst>
          </p:cNvPr>
          <p:cNvSpPr txBox="1"/>
          <p:nvPr/>
        </p:nvSpPr>
        <p:spPr>
          <a:xfrm>
            <a:off x="0" y="621589"/>
            <a:ext cx="1219199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1 Fig. Distribution of propensity scores in the unmatched (A) and matched groups (B).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2153EDC2-8700-57D7-E87A-ED17B9BF9E3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8539"/>
          <a:stretch/>
        </p:blipFill>
        <p:spPr>
          <a:xfrm>
            <a:off x="445533" y="2736600"/>
            <a:ext cx="5566129" cy="3004441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01392726-138B-D8D4-73C6-89DE3615731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7072"/>
          <a:stretch/>
        </p:blipFill>
        <p:spPr>
          <a:xfrm>
            <a:off x="6307013" y="2763833"/>
            <a:ext cx="5482737" cy="30044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590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67</Words>
  <Application>Microsoft Office PowerPoint</Application>
  <PresentationFormat>ワイド画面</PresentationFormat>
  <Paragraphs>1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野 雄康</dc:creator>
  <cp:lastModifiedBy>雄康 大野</cp:lastModifiedBy>
  <cp:revision>22</cp:revision>
  <dcterms:created xsi:type="dcterms:W3CDTF">2020-10-04T09:03:25Z</dcterms:created>
  <dcterms:modified xsi:type="dcterms:W3CDTF">2024-11-12T11:55:00Z</dcterms:modified>
</cp:coreProperties>
</file>